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9" r:id="rId4"/>
    <p:sldId id="265" r:id="rId5"/>
    <p:sldId id="268" r:id="rId6"/>
    <p:sldId id="257" r:id="rId7"/>
    <p:sldId id="262" r:id="rId8"/>
    <p:sldId id="264" r:id="rId9"/>
    <p:sldId id="261" r:id="rId10"/>
    <p:sldId id="267" r:id="rId11"/>
    <p:sldId id="263" r:id="rId12"/>
    <p:sldId id="266" r:id="rId13"/>
    <p:sldId id="260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7" Type="http://schemas.openxmlformats.org/officeDocument/2006/relationships/tableStyles" Target="tableStyles.xml"/><Relationship Id="rId16" Type="http://schemas.openxmlformats.org/officeDocument/2006/relationships/viewProps" Target="viewProps.xml"/><Relationship Id="rId15" Type="http://schemas.openxmlformats.org/officeDocument/2006/relationships/presProps" Target="presProps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17.xml"/><Relationship Id="rId8" Type="http://schemas.openxmlformats.org/officeDocument/2006/relationships/image" Target="../media/image62.png"/><Relationship Id="rId7" Type="http://schemas.openxmlformats.org/officeDocument/2006/relationships/tags" Target="../tags/tag16.xml"/><Relationship Id="rId6" Type="http://schemas.openxmlformats.org/officeDocument/2006/relationships/image" Target="../media/image61.png"/><Relationship Id="rId5" Type="http://schemas.openxmlformats.org/officeDocument/2006/relationships/image" Target="../media/image60.png"/><Relationship Id="rId4" Type="http://schemas.openxmlformats.org/officeDocument/2006/relationships/tags" Target="../tags/tag15.xml"/><Relationship Id="rId3" Type="http://schemas.openxmlformats.org/officeDocument/2006/relationships/tags" Target="../tags/tag14.xml"/><Relationship Id="rId21" Type="http://schemas.openxmlformats.org/officeDocument/2006/relationships/slideLayout" Target="../slideLayouts/slideLayout2.xml"/><Relationship Id="rId20" Type="http://schemas.openxmlformats.org/officeDocument/2006/relationships/tags" Target="../tags/tag24.xml"/><Relationship Id="rId2" Type="http://schemas.openxmlformats.org/officeDocument/2006/relationships/image" Target="../media/image59.png"/><Relationship Id="rId19" Type="http://schemas.openxmlformats.org/officeDocument/2006/relationships/tags" Target="../tags/tag23.xml"/><Relationship Id="rId18" Type="http://schemas.openxmlformats.org/officeDocument/2006/relationships/tags" Target="../tags/tag22.xml"/><Relationship Id="rId17" Type="http://schemas.openxmlformats.org/officeDocument/2006/relationships/image" Target="../media/image66.png"/><Relationship Id="rId16" Type="http://schemas.openxmlformats.org/officeDocument/2006/relationships/tags" Target="../tags/tag21.xml"/><Relationship Id="rId15" Type="http://schemas.openxmlformats.org/officeDocument/2006/relationships/tags" Target="../tags/tag20.xml"/><Relationship Id="rId14" Type="http://schemas.openxmlformats.org/officeDocument/2006/relationships/image" Target="../media/image65.png"/><Relationship Id="rId13" Type="http://schemas.openxmlformats.org/officeDocument/2006/relationships/tags" Target="../tags/tag19.xml"/><Relationship Id="rId12" Type="http://schemas.openxmlformats.org/officeDocument/2006/relationships/image" Target="../media/image64.png"/><Relationship Id="rId11" Type="http://schemas.openxmlformats.org/officeDocument/2006/relationships/image" Target="../media/image63.png"/><Relationship Id="rId10" Type="http://schemas.openxmlformats.org/officeDocument/2006/relationships/tags" Target="../tags/tag18.xml"/><Relationship Id="rId1" Type="http://schemas.openxmlformats.org/officeDocument/2006/relationships/tags" Target="../tags/tag13.xml"/></Relationships>
</file>

<file path=ppt/slides/_rels/slide1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image" Target="../media/image67.png"/></Relationships>
</file>

<file path=ppt/slides/_rels/slide1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image" Target="../media/image78.png"/><Relationship Id="rId5" Type="http://schemas.openxmlformats.org/officeDocument/2006/relationships/image" Target="../media/image77.png"/><Relationship Id="rId4" Type="http://schemas.openxmlformats.org/officeDocument/2006/relationships/image" Target="../media/image76.png"/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image" Target="../media/image73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14.png"/><Relationship Id="rId7" Type="http://schemas.openxmlformats.org/officeDocument/2006/relationships/image" Target="../media/image13.png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png"/><Relationship Id="rId8" Type="http://schemas.openxmlformats.org/officeDocument/2006/relationships/tags" Target="../tags/tag5.xml"/><Relationship Id="rId7" Type="http://schemas.openxmlformats.org/officeDocument/2006/relationships/image" Target="../media/image17.png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image" Target="../media/image16.png"/><Relationship Id="rId3" Type="http://schemas.openxmlformats.org/officeDocument/2006/relationships/tags" Target="../tags/tag2.xml"/><Relationship Id="rId2" Type="http://schemas.openxmlformats.org/officeDocument/2006/relationships/image" Target="../media/image15.png"/><Relationship Id="rId17" Type="http://schemas.openxmlformats.org/officeDocument/2006/relationships/slideLayout" Target="../slideLayouts/slideLayout2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tags" Target="../tags/tag7.xml"/><Relationship Id="rId10" Type="http://schemas.openxmlformats.org/officeDocument/2006/relationships/tags" Target="../tags/tag6.xml"/><Relationship Id="rId1" Type="http://schemas.openxmlformats.org/officeDocument/2006/relationships/tags" Target="../tags/tag1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26.png"/><Relationship Id="rId7" Type="http://schemas.openxmlformats.org/officeDocument/2006/relationships/image" Target="../media/image25.png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image" Target="../media/image19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34.png"/><Relationship Id="rId7" Type="http://schemas.openxmlformats.org/officeDocument/2006/relationships/image" Target="../media/image33.png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42.png"/><Relationship Id="rId7" Type="http://schemas.openxmlformats.org/officeDocument/2006/relationships/image" Target="../media/image41.png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50.png"/><Relationship Id="rId7" Type="http://schemas.openxmlformats.org/officeDocument/2006/relationships/image" Target="../media/image49.png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image" Target="../media/image43.png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54.png"/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image" Target="../media/image51.png"/></Relationships>
</file>

<file path=ppt/slides/_rels/slide9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58.png"/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image" Target="../media/image5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59155" y="960755"/>
            <a:ext cx="2538730" cy="137668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2075" y="443230"/>
            <a:ext cx="767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2-A</a:t>
            </a:r>
            <a:endParaRPr lang="en-US" altLang="zh-CN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62245" y="1027430"/>
            <a:ext cx="1748155" cy="162433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4465" y="2794000"/>
            <a:ext cx="1765935" cy="184785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18015" y="755015"/>
            <a:ext cx="1414145" cy="198247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7850" y="2910840"/>
            <a:ext cx="1464310" cy="194564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3935" y="2651760"/>
            <a:ext cx="2281555" cy="193357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0500" y="148018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92075" y="338772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3550920" y="146494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3390265" y="3533775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5252720" y="34353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Fig2-B</a:t>
            </a:r>
            <a:endParaRPr lang="en-US" altLang="zh-CN"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696325" y="34353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Fig2-C</a:t>
            </a:r>
            <a:endParaRPr lang="en-US" altLang="zh-CN">
              <a:sym typeface="+mn-ea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516120" y="146494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4419600" y="353377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174230" y="148018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11200765" y="1480185"/>
            <a:ext cx="8121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8542655" y="3836670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7187565" y="359918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11119485" y="383667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8494395" y="1480185"/>
            <a:ext cx="8813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612265" y="1786255"/>
            <a:ext cx="1350645" cy="1548130"/>
          </a:xfrm>
          <a:prstGeom prst="rect">
            <a:avLst/>
          </a:prstGeom>
        </p:spPr>
      </p:pic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697865" y="2376170"/>
            <a:ext cx="838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c-Myc</a:t>
            </a:r>
            <a:endParaRPr lang="en-US" altLang="zh-CN"/>
          </a:p>
        </p:txBody>
      </p:sp>
      <p:pic>
        <p:nvPicPr>
          <p:cNvPr id="7" name="图片 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5023485" y="1652905"/>
            <a:ext cx="1303655" cy="153924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9240" y="152400"/>
            <a:ext cx="1496695" cy="146621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539240" y="5012055"/>
            <a:ext cx="1311910" cy="1373505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9"/>
            </p:custDataLst>
          </p:nvPr>
        </p:nvSpPr>
        <p:spPr>
          <a:xfrm>
            <a:off x="612140" y="5464175"/>
            <a:ext cx="8483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5071745" y="4937760"/>
            <a:ext cx="1099820" cy="14478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23180" y="59055"/>
            <a:ext cx="1203960" cy="149733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5071745" y="3334385"/>
            <a:ext cx="1103630" cy="1509395"/>
          </a:xfrm>
          <a:prstGeom prst="rect">
            <a:avLst/>
          </a:prstGeom>
        </p:spPr>
      </p:pic>
      <p:sp>
        <p:nvSpPr>
          <p:cNvPr id="3" name="文本框 2"/>
          <p:cNvSpPr txBox="1"/>
          <p:nvPr>
            <p:custDataLst>
              <p:tags r:id="rId15"/>
            </p:custDataLst>
          </p:nvPr>
        </p:nvSpPr>
        <p:spPr>
          <a:xfrm>
            <a:off x="774065" y="3929380"/>
            <a:ext cx="686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TKT</a:t>
            </a:r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1539240" y="3502025"/>
            <a:ext cx="1342390" cy="1342390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454025" y="395605"/>
            <a:ext cx="10064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P: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612140" y="763905"/>
            <a:ext cx="7219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B:Ub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017010" y="468630"/>
            <a:ext cx="10064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P:c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232910" y="836930"/>
            <a:ext cx="7219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IB:Ub</a:t>
            </a:r>
            <a:endParaRPr lang="zh-CN" altLang="en-US"/>
          </a:p>
        </p:txBody>
      </p:sp>
      <p:sp>
        <p:nvSpPr>
          <p:cNvPr id="19" name="文本框 18"/>
          <p:cNvSpPr txBox="1"/>
          <p:nvPr>
            <p:custDataLst>
              <p:tags r:id="rId18"/>
            </p:custDataLst>
          </p:nvPr>
        </p:nvSpPr>
        <p:spPr>
          <a:xfrm>
            <a:off x="4185285" y="2376170"/>
            <a:ext cx="838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 c-Myc</a:t>
            </a:r>
            <a:endParaRPr lang="en-US" altLang="zh-CN"/>
          </a:p>
        </p:txBody>
      </p:sp>
      <p:sp>
        <p:nvSpPr>
          <p:cNvPr id="20" name="文本框 19"/>
          <p:cNvSpPr txBox="1"/>
          <p:nvPr>
            <p:custDataLst>
              <p:tags r:id="rId19"/>
            </p:custDataLst>
          </p:nvPr>
        </p:nvSpPr>
        <p:spPr>
          <a:xfrm>
            <a:off x="4268470" y="3929380"/>
            <a:ext cx="6864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TKT</a:t>
            </a:r>
            <a:endParaRPr lang="zh-CN" altLang="en-US"/>
          </a:p>
        </p:txBody>
      </p:sp>
      <p:sp>
        <p:nvSpPr>
          <p:cNvPr id="21" name="文本框 20"/>
          <p:cNvSpPr txBox="1"/>
          <p:nvPr>
            <p:custDataLst>
              <p:tags r:id="rId20"/>
            </p:custDataLst>
          </p:nvPr>
        </p:nvSpPr>
        <p:spPr>
          <a:xfrm>
            <a:off x="4185285" y="5514975"/>
            <a:ext cx="8483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129280" y="2376170"/>
            <a:ext cx="8299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6405245" y="2376170"/>
            <a:ext cx="1039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3020695" y="3989070"/>
            <a:ext cx="9385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6341745" y="4051935"/>
            <a:ext cx="8445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3048000" y="5601970"/>
            <a:ext cx="77660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6327140" y="5514975"/>
            <a:ext cx="817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270510" y="59055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I 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3683000" y="6350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J </a:t>
            </a:r>
            <a:endParaRPr lang="en-US" altLang="zh-CN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71780" y="174625"/>
            <a:ext cx="8699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5-A</a:t>
            </a:r>
            <a:endParaRPr lang="en-US" altLang="zh-CN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12290" y="546735"/>
            <a:ext cx="1926590" cy="143637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12290" y="2337435"/>
            <a:ext cx="1927225" cy="122618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680085" y="913765"/>
            <a:ext cx="12338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-Myc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709295" y="2766695"/>
            <a:ext cx="904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12290" y="3984625"/>
            <a:ext cx="1981200" cy="122555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09295" y="441325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38365" y="2213610"/>
            <a:ext cx="1557655" cy="147510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38365" y="3919220"/>
            <a:ext cx="1521460" cy="147447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38365" y="472440"/>
            <a:ext cx="1452245" cy="151066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7468870" y="454660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6127750" y="454660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6276975" y="2656205"/>
            <a:ext cx="904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6276975" y="825500"/>
            <a:ext cx="847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c-Myc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3887470" y="999490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8804910" y="825500"/>
            <a:ext cx="10902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3834765" y="276669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8915400" y="2656205"/>
            <a:ext cx="7867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3887470" y="4472305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8926195" y="4546600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6202045" y="178435"/>
            <a:ext cx="8699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5-D</a:t>
            </a:r>
            <a:endParaRPr lang="en-US" altLang="zh-CN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7915" y="2265045"/>
            <a:ext cx="1229995" cy="140589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26695" y="126365"/>
            <a:ext cx="7962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6-E   </a:t>
            </a:r>
            <a:endParaRPr lang="en-US" altLang="zh-CN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3310" y="3784600"/>
            <a:ext cx="1244600" cy="140398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9500" y="1058545"/>
            <a:ext cx="1248410" cy="10928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19405" y="1197610"/>
            <a:ext cx="981075" cy="2533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2546350" y="1197610"/>
            <a:ext cx="10604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2490" y="2247265"/>
            <a:ext cx="1069975" cy="140589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2490" y="862330"/>
            <a:ext cx="1070610" cy="121475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81700" y="3761105"/>
            <a:ext cx="1041400" cy="142748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5151755" y="423164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39065" y="410527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065395" y="1197610"/>
            <a:ext cx="981075" cy="25336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427355" y="2681605"/>
            <a:ext cx="6559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TKT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 flipH="1">
            <a:off x="5065395" y="2681605"/>
            <a:ext cx="728980" cy="38925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TKT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171055" y="1197610"/>
            <a:ext cx="10604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2546350" y="268160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7160260" y="2681605"/>
            <a:ext cx="83947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2422525" y="4165600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7171055" y="4231640"/>
            <a:ext cx="887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4998085" y="253365"/>
            <a:ext cx="7962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 6-F   </a:t>
            </a:r>
            <a:endParaRPr lang="en-US" altLang="zh-CN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82700" y="2445385"/>
            <a:ext cx="1125220" cy="115125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2700" y="2933065"/>
            <a:ext cx="1261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N-cadherin</a:t>
            </a:r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9520" y="5422900"/>
            <a:ext cx="1176655" cy="10674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95275" y="5761355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9520" y="3921760"/>
            <a:ext cx="1169035" cy="117602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0" y="4340860"/>
            <a:ext cx="1362710" cy="3917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Vimentin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8740" y="690245"/>
            <a:ext cx="1067435" cy="118872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2700" y="1143635"/>
            <a:ext cx="13976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-cadherin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77740" y="502285"/>
            <a:ext cx="1057910" cy="137668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92345" y="2035175"/>
            <a:ext cx="999490" cy="148526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9950" y="5357495"/>
            <a:ext cx="1155700" cy="130556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85665" y="3645535"/>
            <a:ext cx="1149985" cy="140335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478405" y="5761355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944235" y="5826125"/>
            <a:ext cx="10140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2478405" y="4364355"/>
            <a:ext cx="8604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4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944235" y="4364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4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2478405" y="2844165"/>
            <a:ext cx="9277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30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5835650" y="2844165"/>
            <a:ext cx="8940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30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2532380" y="1143635"/>
            <a:ext cx="9264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25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5835650" y="1142365"/>
            <a:ext cx="8940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125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3575050" y="1059815"/>
            <a:ext cx="13976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-cadherin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491230" y="2844165"/>
            <a:ext cx="1261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N-cadherin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3534410" y="4340860"/>
            <a:ext cx="1362710" cy="39179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Vimentin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763645" y="5895340"/>
            <a:ext cx="83312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295275" y="205740"/>
            <a:ext cx="7670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2-J</a:t>
            </a:r>
            <a:endParaRPr lang="en-US" altLang="zh-CN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" name="图片 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560830" y="1203325"/>
            <a:ext cx="1814830" cy="173863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622925" y="1222375"/>
            <a:ext cx="1786255" cy="1719580"/>
          </a:xfrm>
          <a:prstGeom prst="rect">
            <a:avLst/>
          </a:prstGeom>
        </p:spPr>
      </p:pic>
      <p:sp>
        <p:nvSpPr>
          <p:cNvPr id="14" name="文本框 13"/>
          <p:cNvSpPr txBox="1"/>
          <p:nvPr>
            <p:custDataLst>
              <p:tags r:id="rId5"/>
            </p:custDataLst>
          </p:nvPr>
        </p:nvSpPr>
        <p:spPr>
          <a:xfrm>
            <a:off x="782320" y="3993515"/>
            <a:ext cx="56261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TKT</a:t>
            </a:r>
            <a:endParaRPr lang="zh-CN" altLang="en-US"/>
          </a:p>
          <a:p>
            <a:endParaRPr lang="zh-CN" altLang="en-US"/>
          </a:p>
        </p:txBody>
      </p:sp>
      <p:pic>
        <p:nvPicPr>
          <p:cNvPr id="15" name="图片 14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1560830" y="3256915"/>
            <a:ext cx="1881505" cy="171005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5617210" y="3138170"/>
            <a:ext cx="1852930" cy="1681480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10"/>
            </p:custDataLst>
          </p:nvPr>
        </p:nvSpPr>
        <p:spPr>
          <a:xfrm>
            <a:off x="782320" y="1793875"/>
            <a:ext cx="7112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RAF1</a:t>
            </a:r>
            <a:endParaRPr lang="en-US" altLang="zh-CN"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11"/>
            </p:custDataLst>
          </p:nvPr>
        </p:nvSpPr>
        <p:spPr>
          <a:xfrm>
            <a:off x="3562350" y="1701165"/>
            <a:ext cx="1180465" cy="4610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p>
            <a:r>
              <a:rPr lang="en-US" altLang="zh-CN"/>
              <a:t>	73kDa</a:t>
            </a:r>
            <a:endParaRPr lang="zh-CN" altLang="en-US"/>
          </a:p>
        </p:txBody>
      </p:sp>
      <p:sp>
        <p:nvSpPr>
          <p:cNvPr id="3" name="文本框 2"/>
          <p:cNvSpPr txBox="1"/>
          <p:nvPr>
            <p:custDataLst>
              <p:tags r:id="rId12"/>
            </p:custDataLst>
          </p:nvPr>
        </p:nvSpPr>
        <p:spPr>
          <a:xfrm>
            <a:off x="6771005" y="3927475"/>
            <a:ext cx="1775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73kDa</a:t>
            </a:r>
            <a:endParaRPr lang="zh-CN" altLang="en-US"/>
          </a:p>
        </p:txBody>
      </p:sp>
      <p:sp>
        <p:nvSpPr>
          <p:cNvPr id="5" name="文本框 4"/>
          <p:cNvSpPr txBox="1"/>
          <p:nvPr>
            <p:custDataLst>
              <p:tags r:id="rId13"/>
            </p:custDataLst>
          </p:nvPr>
        </p:nvSpPr>
        <p:spPr>
          <a:xfrm>
            <a:off x="4742815" y="3993515"/>
            <a:ext cx="7112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RAF1</a:t>
            </a:r>
            <a:endParaRPr lang="en-US" altLang="zh-CN"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14"/>
            </p:custDataLst>
          </p:nvPr>
        </p:nvSpPr>
        <p:spPr>
          <a:xfrm>
            <a:off x="4929505" y="1898650"/>
            <a:ext cx="562610" cy="3479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TKT</a:t>
            </a:r>
            <a:endParaRPr lang="zh-CN" altLang="en-US"/>
          </a:p>
          <a:p>
            <a:endParaRPr lang="zh-CN" altLang="en-US"/>
          </a:p>
        </p:txBody>
      </p:sp>
      <p:sp>
        <p:nvSpPr>
          <p:cNvPr id="7" name="文本框 6"/>
          <p:cNvSpPr txBox="1"/>
          <p:nvPr>
            <p:custDataLst>
              <p:tags r:id="rId15"/>
            </p:custDataLst>
          </p:nvPr>
        </p:nvSpPr>
        <p:spPr>
          <a:xfrm>
            <a:off x="6811645" y="1793875"/>
            <a:ext cx="18218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68kDa</a:t>
            </a:r>
            <a:endParaRPr lang="zh-CN" altLang="en-US"/>
          </a:p>
        </p:txBody>
      </p:sp>
      <p:sp>
        <p:nvSpPr>
          <p:cNvPr id="8" name="文本框 7"/>
          <p:cNvSpPr txBox="1"/>
          <p:nvPr>
            <p:custDataLst>
              <p:tags r:id="rId16"/>
            </p:custDataLst>
          </p:nvPr>
        </p:nvSpPr>
        <p:spPr>
          <a:xfrm>
            <a:off x="2637790" y="3794760"/>
            <a:ext cx="1941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	68kDa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606425" y="591820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F</a:t>
            </a:r>
            <a:endParaRPr lang="en-US" altLang="zh-CN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" name="文本框 8"/>
          <p:cNvSpPr txBox="1"/>
          <p:nvPr/>
        </p:nvSpPr>
        <p:spPr>
          <a:xfrm>
            <a:off x="157480" y="81280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G</a:t>
            </a:r>
            <a:endParaRPr lang="en-US" altLang="zh-CN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10920" y="394335"/>
            <a:ext cx="1046480" cy="14579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1395" y="1925955"/>
            <a:ext cx="1041400" cy="158940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1395" y="3589020"/>
            <a:ext cx="1046480" cy="132969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1395" y="4992370"/>
            <a:ext cx="1056005" cy="1651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42380" y="305435"/>
            <a:ext cx="1144905" cy="132016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42380" y="1763395"/>
            <a:ext cx="1083310" cy="152527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42380" y="3426460"/>
            <a:ext cx="972820" cy="140335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2380" y="4903470"/>
            <a:ext cx="1043940" cy="1651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6409690" y="575691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1066165" y="5845810"/>
            <a:ext cx="976630" cy="2940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noAutofit/>
          </a:bodyPr>
          <a:p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66675" y="577151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5330190" y="575691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521575" y="5756910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2241550" y="5771515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264795" y="4077970"/>
            <a:ext cx="659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A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2124710" y="40779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7521575" y="40779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5614670" y="4077970"/>
            <a:ext cx="6597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A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62560" y="2466340"/>
            <a:ext cx="591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>
            <a:off x="2124710" y="246634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7562850" y="229616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5682615" y="2296160"/>
            <a:ext cx="591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141605" y="781685"/>
            <a:ext cx="8597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IB:Flag</a:t>
            </a:r>
            <a:endParaRPr lang="en-US" altLang="zh-CN">
              <a:sym typeface="+mn-ea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414645" y="725170"/>
            <a:ext cx="8597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IB:HA</a:t>
            </a:r>
            <a:endParaRPr lang="en-US" altLang="zh-CN">
              <a:sym typeface="+mn-ea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181225" y="781685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>
            <a:off x="7555230" y="725170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42745" y="2070100"/>
            <a:ext cx="1320800" cy="12477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11835" y="2491105"/>
            <a:ext cx="643255" cy="2889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c-raf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203200" y="164465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I</a:t>
            </a:r>
            <a:endParaRPr lang="en-US" altLang="zh-CN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3065" y="3429000"/>
            <a:ext cx="1258570" cy="12954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0320" y="3893820"/>
            <a:ext cx="1642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c-Raf(Ser338)</a:t>
            </a:r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9245" y="5109845"/>
            <a:ext cx="1342390" cy="1256030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561340" y="560959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15440" y="473075"/>
            <a:ext cx="1348105" cy="136779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781685" y="1002030"/>
            <a:ext cx="573405" cy="4044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13500" y="3429000"/>
            <a:ext cx="1171575" cy="142367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1595" y="344170"/>
            <a:ext cx="1172845" cy="13208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11595" y="1866900"/>
            <a:ext cx="1172210" cy="145097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12865" y="5109845"/>
            <a:ext cx="1172210" cy="13462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838190" y="880110"/>
            <a:ext cx="573405" cy="40449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5641340" y="2382520"/>
            <a:ext cx="643255" cy="2889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c-raf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4692650" y="4020820"/>
            <a:ext cx="1642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c-Raf(Ser338)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5391150" y="5609590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3108960" y="1038225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7701280" y="88011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3108960" y="2529205"/>
            <a:ext cx="8350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7710805" y="243268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108960" y="3900170"/>
            <a:ext cx="77851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7663180" y="405701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73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034030" y="5681345"/>
            <a:ext cx="81788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710805" y="5681345"/>
            <a:ext cx="8959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559425" y="2051685"/>
            <a:ext cx="1172845" cy="137668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9105" y="2186940"/>
            <a:ext cx="1426845" cy="13462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4495" y="3773805"/>
            <a:ext cx="1465580" cy="113220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483870" y="2675890"/>
            <a:ext cx="12452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RK1/2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363855" y="4155440"/>
            <a:ext cx="127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ERK1/2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59425" y="3615055"/>
            <a:ext cx="1127125" cy="131635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9425" y="532765"/>
            <a:ext cx="1031240" cy="132270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737870" y="1011555"/>
            <a:ext cx="802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74495" y="5105400"/>
            <a:ext cx="1386840" cy="137414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784860" y="577024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59425" y="5105400"/>
            <a:ext cx="1031240" cy="137096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74495" y="634365"/>
            <a:ext cx="1465580" cy="131191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03200" y="164465"/>
            <a:ext cx="954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</a:t>
            </a:r>
            <a:r>
              <a:rPr lang="en-US" altLang="zh-CN"/>
              <a:t>ig3-J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669790" y="948690"/>
            <a:ext cx="802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TKT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4669790" y="2555875"/>
            <a:ext cx="12452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ERK1/2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436110" y="4163060"/>
            <a:ext cx="1270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ERK1/2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820285" y="5770245"/>
            <a:ext cx="9442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274060" y="1011555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6732270" y="948690"/>
            <a:ext cx="13271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68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3228340" y="2783840"/>
            <a:ext cx="83248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6826250" y="2675890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3228340" y="4163060"/>
            <a:ext cx="77152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6856730" y="4163060"/>
            <a:ext cx="826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4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3228340" y="5770245"/>
            <a:ext cx="95186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6826250" y="5770245"/>
            <a:ext cx="84645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831840" y="678180"/>
            <a:ext cx="1257935" cy="133794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57480" y="154940"/>
            <a:ext cx="9055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D</a:t>
            </a:r>
            <a:endParaRPr lang="en-US" altLang="zh-CN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1840" y="2128520"/>
            <a:ext cx="1265555" cy="137223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0" y="2704465"/>
            <a:ext cx="1207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S62-Myc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157480" y="1193800"/>
            <a:ext cx="7905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31840" y="5171440"/>
            <a:ext cx="1242695" cy="145859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8765" y="5853430"/>
            <a:ext cx="8413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7135" y="2128520"/>
            <a:ext cx="1322070" cy="137223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7450" y="3613150"/>
            <a:ext cx="1341755" cy="145732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6035" y="4157980"/>
            <a:ext cx="11811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T58-Myc</a:t>
            </a:r>
            <a:endParaRPr lang="zh-CN" altLang="en-US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07135" y="678180"/>
            <a:ext cx="1367155" cy="133794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31840" y="3613150"/>
            <a:ext cx="1169035" cy="144589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68400" y="5182870"/>
            <a:ext cx="1386205" cy="1458595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978400" y="1103630"/>
            <a:ext cx="7905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4561840" y="2757170"/>
            <a:ext cx="120713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S62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4587875" y="4237355"/>
            <a:ext cx="11811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p-T58-Myc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927600" y="5899150"/>
            <a:ext cx="8413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2759075" y="110363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7202805" y="110363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2744470" y="2586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7160260" y="263080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7156450" y="4237355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2682875" y="4157980"/>
            <a:ext cx="78549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2682875" y="5899150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9" name="文本框 28"/>
          <p:cNvSpPr txBox="1"/>
          <p:nvPr/>
        </p:nvSpPr>
        <p:spPr>
          <a:xfrm>
            <a:off x="7158355" y="5856605"/>
            <a:ext cx="79883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15745" y="1041400"/>
            <a:ext cx="2766060" cy="129921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7051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E </a:t>
            </a:r>
            <a:endParaRPr lang="en-US" altLang="zh-CN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5745" y="2594610"/>
            <a:ext cx="2728595" cy="125285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48095" y="2594610"/>
            <a:ext cx="2728595" cy="129984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1265" y="1041400"/>
            <a:ext cx="2765425" cy="1211580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551815" y="14630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524510" y="3060700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5444490" y="14630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5430520" y="3060700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4281805" y="14630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>
            <a:off x="9076690" y="146304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4345305" y="314007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9177655" y="3140075"/>
            <a:ext cx="88519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23" name="文本框 22"/>
          <p:cNvSpPr txBox="1"/>
          <p:nvPr/>
        </p:nvSpPr>
        <p:spPr>
          <a:xfrm>
            <a:off x="548005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F </a:t>
            </a:r>
            <a:endParaRPr lang="en-US" altLang="zh-CN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1" name="图片 1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361440" y="662940"/>
            <a:ext cx="2267585" cy="13074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0015" y="2473960"/>
            <a:ext cx="2239010" cy="129095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13805" y="662940"/>
            <a:ext cx="2167255" cy="130048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3805" y="2392680"/>
            <a:ext cx="2168525" cy="137223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70510" y="21971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G 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403850" y="163830"/>
            <a:ext cx="8680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4-H 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29260" y="10947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5403850" y="1094740"/>
            <a:ext cx="86677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c-Myc</a:t>
            </a:r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429260" y="2935605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5338445" y="3001645"/>
            <a:ext cx="8807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β-actin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3694430" y="10947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8592185" y="1094740"/>
            <a:ext cx="123444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57kDa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3775075" y="300164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8576945" y="2935605"/>
            <a:ext cx="8566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/>
              <a:t>43kDa</a:t>
            </a:r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0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1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2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13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4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5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6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7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8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19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20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1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2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3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24.xml><?xml version="1.0" encoding="utf-8"?>
<p:tagLst xmlns:p="http://schemas.openxmlformats.org/presentationml/2006/main">
  <p:tag name="KSO_WM_DIAGRAM_VIRTUALLY_FRAME" val="{&quot;height&quot;:543.1,&quot;left&quot;:65.65,&quot;top&quot;:25.6,&quot;width&quot;:755.8}"/>
</p:tagLst>
</file>

<file path=ppt/tags/tag3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4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5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6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7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8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ags/tag9.xml><?xml version="1.0" encoding="utf-8"?>
<p:tagLst xmlns:p="http://schemas.openxmlformats.org/presentationml/2006/main">
  <p:tag name="KSO_WM_DIAGRAM_VIRTUALLY_FRAME" val="{&quot;height&quot;:296.35,&quot;left&quot;:61.6,&quot;top&quot;:94.75,&quot;width&quot;:618.2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04</Words>
  <Application>WPS 演示</Application>
  <PresentationFormat>宽屏</PresentationFormat>
  <Paragraphs>352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9" baseType="lpstr">
      <vt:lpstr>Arial</vt:lpstr>
      <vt:lpstr>宋体</vt:lpstr>
      <vt:lpstr>Wingdings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灼灼其华</cp:lastModifiedBy>
  <cp:revision>20</cp:revision>
  <dcterms:created xsi:type="dcterms:W3CDTF">2023-08-09T12:44:00Z</dcterms:created>
  <dcterms:modified xsi:type="dcterms:W3CDTF">2026-02-11T13:51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572673B2B18F43E6A3F69DE1FC4D4255_12</vt:lpwstr>
  </property>
</Properties>
</file>